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08788" cy="9823450"/>
  <p:defaultTextStyle>
    <a:defPPr>
      <a:defRPr lang="el-G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-2664" y="-7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38BDB8-89C1-42FC-84FF-1A9BF6317E5B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394E5-88F4-4A4D-9370-DD923BD8F683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5C0E16-5F5B-4C4C-87AB-88A6129EEF32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F878F6-4BB6-4866-A352-DEFE6BD760A5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793E94-8D80-44B5-ADF5-446E7B505E2C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F9CE4B-43BD-4EA7-99C1-255E1BBE576B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0E07C7-2812-4FB4-9FA8-F341A3E86251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71E028-EFB0-4199-8721-D483A3946D5E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E805CF-B6F4-4804-BD64-5758C3F41BCC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F0B692-A720-4BD0-85F3-6D11F7671106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6E3ACC-983C-40C2-8CFE-5CAA76109AEE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D4C5CC-F03C-40DF-8804-F411055BF838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036869-FFB5-41D5-ADFD-8F371D7F5B6D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2B035E-6CF1-4E67-A4B2-D95AB93ABA06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024A17-4C0B-49D9-A466-B991B32C1662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0EA544-46D9-42E4-9ADB-65725F5508A6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31EF54-281A-433B-B948-B5CC121F9C53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C57A73-6416-4E13-8DAE-9F5257B2B835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4A274A-E1AC-4903-96D7-957B8D6A1C00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563D2D-372C-44ED-AF92-E0DB27C27217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l-GR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A4B553-853E-4CAC-9088-15FB91799203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AB62AC-BC65-4CE2-AEF3-2BA0D5B2F9DB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l-GR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D1B3879-F383-4FF4-B01E-D2B5D9D646B2}" type="datetimeFigureOut">
              <a:rPr lang="el-GR"/>
              <a:pPr>
                <a:defRPr/>
              </a:pPr>
              <a:t>8/8/2013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8448F74-BA04-4559-8E0A-1364CB783411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3" name="Picture 12" descr="intact_flow2_NM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1600200"/>
            <a:ext cx="9144000" cy="43529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13314" name="Rectangle 4"/>
          <p:cNvSpPr>
            <a:spLocks noChangeArrowheads="1"/>
          </p:cNvSpPr>
          <p:nvPr/>
        </p:nvSpPr>
        <p:spPr bwMode="auto">
          <a:xfrm>
            <a:off x="-3175" y="190500"/>
            <a:ext cx="9147175" cy="14927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Additional File 1</a:t>
            </a:r>
          </a:p>
          <a:p>
            <a:pPr algn="just"/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The uploading process flowchart for the </a:t>
            </a:r>
            <a:r>
              <a:rPr lang="en-US" sz="1200" b="1" dirty="0" err="1">
                <a:latin typeface="Times New Roman" pitchFamily="18" charset="0"/>
                <a:cs typeface="Times New Roman" pitchFamily="18" charset="0"/>
              </a:rPr>
              <a:t>IntAct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PPI dataset using MS-SQL Integration Services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print screen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hot)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process comprises three major steps executed in the shown sequence: a) the isolation of the rows referring to interactions between human proteins, b) the updating of the non-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UniPro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interacto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identifiers (IDs) and c) the conversion of all referenc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dentifier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nto PubMe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Ds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PIs with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interacto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or referenc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dentifier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at cannot be corresponded to any element of relevant patching files are collected in respective tables to be updated in a second run of the dataset uploading algorithm.</a:t>
            </a:r>
            <a:endParaRPr lang="el-GR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l-GR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71438" y="1992313"/>
            <a:ext cx="2952750" cy="2339975"/>
          </a:xfrm>
          <a:prstGeom prst="rect">
            <a:avLst/>
          </a:prstGeom>
          <a:noFill/>
          <a:ln w="9525" algn="ctr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l-GR">
              <a:solidFill>
                <a:schemeClr val="lt1"/>
              </a:solidFill>
              <a:latin typeface="+mn-lt"/>
              <a:cs typeface="+mn-cs"/>
            </a:endParaRPr>
          </a:p>
        </p:txBody>
      </p:sp>
      <p:sp>
        <p:nvSpPr>
          <p:cNvPr id="7" name="Text Box 7"/>
          <p:cNvSpPr txBox="1"/>
          <p:nvPr/>
        </p:nvSpPr>
        <p:spPr>
          <a:xfrm>
            <a:off x="42863" y="1976438"/>
            <a:ext cx="1466850" cy="600075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r>
              <a:rPr lang="en-US" sz="1100" b="1" dirty="0">
                <a:solidFill>
                  <a:srgbClr val="000000"/>
                </a:solidFill>
                <a:latin typeface="Arial" charset="0"/>
                <a:cs typeface="Times New Roman" pitchFamily="18" charset="0"/>
              </a:rPr>
              <a:t>(a) Filtering </a:t>
            </a:r>
            <a:r>
              <a:rPr lang="en-US" sz="1100" b="1" dirty="0">
                <a:solidFill>
                  <a:schemeClr val="tx1"/>
                </a:solidFill>
                <a:latin typeface="Arial" charset="0"/>
                <a:cs typeface="Times New Roman" pitchFamily="18" charset="0"/>
              </a:rPr>
              <a:t>in</a:t>
            </a:r>
            <a:r>
              <a:rPr lang="en-US" sz="1100" b="1" dirty="0">
                <a:solidFill>
                  <a:srgbClr val="000000"/>
                </a:solidFill>
                <a:latin typeface="Arial" charset="0"/>
                <a:cs typeface="Times New Roman" pitchFamily="18" charset="0"/>
              </a:rPr>
              <a:t> the human-human PPIs</a:t>
            </a:r>
            <a:endParaRPr lang="el-GR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Rectangle 7"/>
          <p:cNvSpPr>
            <a:spLocks noChangeArrowheads="1"/>
          </p:cNvSpPr>
          <p:nvPr/>
        </p:nvSpPr>
        <p:spPr bwMode="auto">
          <a:xfrm>
            <a:off x="3236913" y="1631950"/>
            <a:ext cx="4545012" cy="2465388"/>
          </a:xfrm>
          <a:prstGeom prst="rect">
            <a:avLst/>
          </a:prstGeom>
          <a:noFill/>
          <a:ln w="9525" algn="ctr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l-GR">
              <a:solidFill>
                <a:schemeClr val="lt1"/>
              </a:solidFill>
              <a:latin typeface="+mn-lt"/>
              <a:cs typeface="+mn-cs"/>
            </a:endParaRPr>
          </a:p>
        </p:txBody>
      </p:sp>
      <p:sp>
        <p:nvSpPr>
          <p:cNvPr id="9" name="Text Box 15"/>
          <p:cNvSpPr txBox="1"/>
          <p:nvPr/>
        </p:nvSpPr>
        <p:spPr>
          <a:xfrm>
            <a:off x="5614988" y="1887538"/>
            <a:ext cx="1571625" cy="533400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r">
              <a:defRPr/>
            </a:pPr>
            <a:r>
              <a:rPr lang="en-US" sz="1100" b="1" dirty="0">
                <a:solidFill>
                  <a:srgbClr val="000000"/>
                </a:solidFill>
                <a:latin typeface="Arial" charset="0"/>
                <a:cs typeface="Times New Roman" pitchFamily="18" charset="0"/>
              </a:rPr>
              <a:t>(b) Updating non </a:t>
            </a:r>
            <a:r>
              <a:rPr lang="en-US" sz="1100" b="1" dirty="0" err="1">
                <a:solidFill>
                  <a:srgbClr val="000000"/>
                </a:solidFill>
                <a:latin typeface="Arial" charset="0"/>
                <a:cs typeface="Times New Roman" pitchFamily="18" charset="0"/>
              </a:rPr>
              <a:t>UniProt</a:t>
            </a:r>
            <a:r>
              <a:rPr lang="en-US" sz="1100" b="1" dirty="0">
                <a:solidFill>
                  <a:srgbClr val="000000"/>
                </a:solidFill>
                <a:latin typeface="Arial" charset="0"/>
                <a:cs typeface="Times New Roman" pitchFamily="18" charset="0"/>
              </a:rPr>
              <a:t> IDs</a:t>
            </a:r>
            <a:endParaRPr lang="el-GR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Rectangle 9"/>
          <p:cNvSpPr>
            <a:spLocks noChangeArrowheads="1"/>
          </p:cNvSpPr>
          <p:nvPr/>
        </p:nvSpPr>
        <p:spPr bwMode="auto">
          <a:xfrm>
            <a:off x="3932238" y="4095750"/>
            <a:ext cx="4654550" cy="1476375"/>
          </a:xfrm>
          <a:prstGeom prst="rect">
            <a:avLst/>
          </a:prstGeom>
          <a:noFill/>
          <a:ln w="9525" algn="ctr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l-GR">
              <a:solidFill>
                <a:schemeClr val="lt1"/>
              </a:solidFill>
              <a:latin typeface="+mn-lt"/>
              <a:cs typeface="+mn-cs"/>
            </a:endParaRPr>
          </a:p>
        </p:txBody>
      </p:sp>
      <p:sp>
        <p:nvSpPr>
          <p:cNvPr id="11" name="Text Box 16"/>
          <p:cNvSpPr txBox="1"/>
          <p:nvPr/>
        </p:nvSpPr>
        <p:spPr>
          <a:xfrm>
            <a:off x="7048500" y="5018088"/>
            <a:ext cx="1571625" cy="590550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/>
          <a:lstStyle/>
          <a:p>
            <a:pPr algn="r">
              <a:defRPr/>
            </a:pPr>
            <a:r>
              <a:rPr lang="en-US" sz="1100" b="1" dirty="0">
                <a:solidFill>
                  <a:srgbClr val="000000"/>
                </a:solidFill>
                <a:latin typeface="Arial" charset="0"/>
                <a:cs typeface="Times New Roman" pitchFamily="18" charset="0"/>
              </a:rPr>
              <a:t>(c) Converting all references into PubMed IDs</a:t>
            </a:r>
            <a:endParaRPr lang="el-GR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13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Klapa</dc:creator>
  <cp:lastModifiedBy>Maria Klapa</cp:lastModifiedBy>
  <cp:revision>10</cp:revision>
  <dcterms:created xsi:type="dcterms:W3CDTF">2013-07-30T17:10:17Z</dcterms:created>
  <dcterms:modified xsi:type="dcterms:W3CDTF">2013-08-08T09:34:15Z</dcterms:modified>
</cp:coreProperties>
</file>